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75" r:id="rId2"/>
    <p:sldId id="261" r:id="rId3"/>
    <p:sldId id="260" r:id="rId4"/>
    <p:sldId id="276" r:id="rId5"/>
    <p:sldId id="262" r:id="rId6"/>
  </p:sldIdLst>
  <p:sldSz cx="6858000" cy="9144000" type="screen4x3"/>
  <p:notesSz cx="6794500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179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2676" y="108"/>
      </p:cViewPr>
      <p:guideLst>
        <p:guide orient="horz" pos="288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2A5390-9DFC-4B0E-8722-9104A63C49D3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38250"/>
            <a:ext cx="2505075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67262"/>
            <a:ext cx="5435600" cy="39004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AU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0BB7FD-F1EB-44A2-957F-60E0A84EAB9B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18319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7242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5242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1207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2330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73276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4892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8252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786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816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6174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6570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559F1-C77A-4EAD-A417-62818BBE362C}" type="datetimeFigureOut">
              <a:rPr lang="en-AU" smtClean="0"/>
              <a:t>8/09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8BA1D-413E-4295-B7CC-5267FF57B3BF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3086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13" Type="http://schemas.openxmlformats.org/officeDocument/2006/relationships/image" Target="../media/image17.tiff"/><Relationship Id="rId18" Type="http://schemas.openxmlformats.org/officeDocument/2006/relationships/image" Target="../media/image2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12" Type="http://schemas.openxmlformats.org/officeDocument/2006/relationships/image" Target="../media/image16.tiff"/><Relationship Id="rId17" Type="http://schemas.openxmlformats.org/officeDocument/2006/relationships/image" Target="../media/image21.tiff"/><Relationship Id="rId2" Type="http://schemas.openxmlformats.org/officeDocument/2006/relationships/image" Target="../media/image6.tiff"/><Relationship Id="rId16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11" Type="http://schemas.openxmlformats.org/officeDocument/2006/relationships/image" Target="../media/image15.tiff"/><Relationship Id="rId5" Type="http://schemas.openxmlformats.org/officeDocument/2006/relationships/image" Target="../media/image9.tiff"/><Relationship Id="rId15" Type="http://schemas.openxmlformats.org/officeDocument/2006/relationships/image" Target="../media/image19.tiff"/><Relationship Id="rId10" Type="http://schemas.openxmlformats.org/officeDocument/2006/relationships/image" Target="../media/image14.tiff"/><Relationship Id="rId19" Type="http://schemas.openxmlformats.org/officeDocument/2006/relationships/image" Target="../media/image23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Relationship Id="rId14" Type="http://schemas.openxmlformats.org/officeDocument/2006/relationships/image" Target="../media/image1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7" Type="http://schemas.openxmlformats.org/officeDocument/2006/relationships/image" Target="../media/image32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tiff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9879" y="4822140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302924" y="4909663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V4-11, 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21" y="5010987"/>
            <a:ext cx="2340000" cy="1869705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59879" y="2532430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3279586" y="2532430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1681928" y="2587065"/>
            <a:ext cx="1207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blast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4616323" y="2587065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blast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452" y="2763562"/>
            <a:ext cx="2880000" cy="2242286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8776" y="2731843"/>
            <a:ext cx="2880000" cy="2274005"/>
          </a:xfrm>
          <a:prstGeom prst="rect">
            <a:avLst/>
          </a:prstGeom>
        </p:spPr>
      </p:pic>
      <p:sp>
        <p:nvSpPr>
          <p:cNvPr id="46" name="Rechteck 45"/>
          <p:cNvSpPr/>
          <p:nvPr/>
        </p:nvSpPr>
        <p:spPr>
          <a:xfrm>
            <a:off x="-69049" y="6880692"/>
            <a:ext cx="692704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binatorial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LIPinB, BV6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L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s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nor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n non-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cerous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,B) IC50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V6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LIPinB/CD95L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lcul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C-H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T29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IT-020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ynergism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lcul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mula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fter Loewe. IC50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gram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low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C50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ken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ynergisitc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(C,D)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broblas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FLIPin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V6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h. Cell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I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95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6 h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2 h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. (E)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V4-11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FLIPin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 µM BV6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h. Cell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0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 TRAIL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i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was measured using the Cell Titer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 Luminescent Cell Viability Assay.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8" name="Grafik 4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474" y="83382"/>
            <a:ext cx="3060000" cy="2395632"/>
          </a:xfrm>
          <a:prstGeom prst="rect">
            <a:avLst/>
          </a:prstGeom>
        </p:spPr>
      </p:pic>
      <p:pic>
        <p:nvPicPr>
          <p:cNvPr id="59" name="Grafik 5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1091" y="116224"/>
            <a:ext cx="3060000" cy="2399540"/>
          </a:xfrm>
          <a:prstGeom prst="rect">
            <a:avLst/>
          </a:prstGeom>
        </p:spPr>
      </p:pic>
      <p:sp>
        <p:nvSpPr>
          <p:cNvPr id="87" name="Textfeld 86"/>
          <p:cNvSpPr txBox="1"/>
          <p:nvPr/>
        </p:nvSpPr>
        <p:spPr>
          <a:xfrm>
            <a:off x="1769474" y="155630"/>
            <a:ext cx="1207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150182" y="155630"/>
            <a:ext cx="1207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59879" y="59234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3279586" y="59234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0346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feld 38"/>
          <p:cNvSpPr txBox="1"/>
          <p:nvPr/>
        </p:nvSpPr>
        <p:spPr>
          <a:xfrm>
            <a:off x="3281033" y="1981147"/>
            <a:ext cx="424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Grafik 3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5108" y="2261190"/>
            <a:ext cx="3561588" cy="2537460"/>
          </a:xfrm>
          <a:prstGeom prst="rect">
            <a:avLst/>
          </a:prstGeom>
        </p:spPr>
      </p:pic>
      <p:sp>
        <p:nvSpPr>
          <p:cNvPr id="41" name="Textfeld 40"/>
          <p:cNvSpPr txBox="1"/>
          <p:nvPr/>
        </p:nvSpPr>
        <p:spPr>
          <a:xfrm>
            <a:off x="4648326" y="2284532"/>
            <a:ext cx="549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Grafik 4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973" y="4820346"/>
            <a:ext cx="3558540" cy="2535936"/>
          </a:xfrm>
          <a:prstGeom prst="rect">
            <a:avLst/>
          </a:prstGeom>
        </p:spPr>
      </p:pic>
      <p:sp>
        <p:nvSpPr>
          <p:cNvPr id="43" name="Textfeld 42"/>
          <p:cNvSpPr txBox="1"/>
          <p:nvPr/>
        </p:nvSpPr>
        <p:spPr>
          <a:xfrm>
            <a:off x="1222992" y="4820346"/>
            <a:ext cx="865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70491" y="4814355"/>
            <a:ext cx="424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13" t="45651" r="64988" b="51607"/>
          <a:stretch/>
        </p:blipFill>
        <p:spPr>
          <a:xfrm>
            <a:off x="4545152" y="5736005"/>
            <a:ext cx="373620" cy="1140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feld 15"/>
          <p:cNvSpPr txBox="1"/>
          <p:nvPr/>
        </p:nvSpPr>
        <p:spPr>
          <a:xfrm>
            <a:off x="5383524" y="5687301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48" t="45650" r="59353" b="49584"/>
          <a:stretch/>
        </p:blipFill>
        <p:spPr>
          <a:xfrm>
            <a:off x="4545151" y="5860440"/>
            <a:ext cx="373621" cy="1983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feld 17"/>
          <p:cNvSpPr txBox="1"/>
          <p:nvPr/>
        </p:nvSpPr>
        <p:spPr>
          <a:xfrm>
            <a:off x="5383524" y="586044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3" t="34910" r="61300" b="62343"/>
          <a:stretch/>
        </p:blipFill>
        <p:spPr>
          <a:xfrm>
            <a:off x="4990144" y="5734809"/>
            <a:ext cx="306098" cy="114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72" t="39846" r="56850" b="55407"/>
          <a:stretch/>
        </p:blipFill>
        <p:spPr>
          <a:xfrm>
            <a:off x="4990144" y="5860843"/>
            <a:ext cx="305560" cy="19751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4" name="Gerade Verbindung mit Pfeil 23"/>
          <p:cNvCxnSpPr/>
          <p:nvPr/>
        </p:nvCxnSpPr>
        <p:spPr>
          <a:xfrm flipH="1">
            <a:off x="5312062" y="579960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5312062" y="5984277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 rot="19609099">
            <a:off x="4552448" y="5413757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 rot="19609099">
            <a:off x="5005300" y="5471660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3991046" y="4814355"/>
            <a:ext cx="424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-37898" y="7219668"/>
            <a:ext cx="689589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 The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ath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SUIT-020 and HT-29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-C)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on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0 (non-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FLIPin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0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 CD95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I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4 h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8 h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72 h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i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on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0 (non-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FLIPin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0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 CD95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ime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Western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ad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r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osu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osu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E,F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 A,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i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Value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rmalis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ward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G) 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tal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sate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IT-02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T29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220747" y="8914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712894" y="2664537"/>
            <a:ext cx="5874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9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Gerade Verbindung mit Pfeil 28"/>
          <p:cNvCxnSpPr/>
          <p:nvPr/>
        </p:nvCxnSpPr>
        <p:spPr>
          <a:xfrm flipH="1">
            <a:off x="1630677" y="278672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1712894" y="2751095"/>
            <a:ext cx="4552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4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Gerade Verbindung mit Pfeil 30"/>
          <p:cNvCxnSpPr/>
          <p:nvPr/>
        </p:nvCxnSpPr>
        <p:spPr>
          <a:xfrm flipH="1">
            <a:off x="1630677" y="2873281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1712894" y="2857917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1630677" y="298010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1712894" y="3083280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43/p4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Gerade Verbindung mit Pfeil 34"/>
          <p:cNvCxnSpPr/>
          <p:nvPr/>
        </p:nvCxnSpPr>
        <p:spPr>
          <a:xfrm flipH="1">
            <a:off x="1630677" y="3195418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H="1">
            <a:off x="1630677" y="3228574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1712894" y="3714535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1630677" y="3836721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feld 44"/>
          <p:cNvSpPr txBox="1"/>
          <p:nvPr/>
        </p:nvSpPr>
        <p:spPr>
          <a:xfrm>
            <a:off x="1712894" y="4434240"/>
            <a:ext cx="4552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Gerade Verbindung mit Pfeil 45"/>
          <p:cNvCxnSpPr/>
          <p:nvPr/>
        </p:nvCxnSpPr>
        <p:spPr>
          <a:xfrm flipH="1">
            <a:off x="1630677" y="4551828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7" name="Tabel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8514925"/>
              </p:ext>
            </p:extLst>
          </p:nvPr>
        </p:nvGraphicFramePr>
        <p:xfrm>
          <a:off x="542676" y="2178468"/>
          <a:ext cx="1080008" cy="46949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50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500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5649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649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649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8" name="Textfeld 47"/>
          <p:cNvSpPr txBox="1"/>
          <p:nvPr/>
        </p:nvSpPr>
        <p:spPr>
          <a:xfrm>
            <a:off x="1554330" y="2287748"/>
            <a:ext cx="12541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 µM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IPinB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2 h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554330" y="2459694"/>
            <a:ext cx="14589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D95L in m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1712894" y="2971859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Gerade Verbindung mit Pfeil 50"/>
          <p:cNvCxnSpPr/>
          <p:nvPr/>
        </p:nvCxnSpPr>
        <p:spPr>
          <a:xfrm flipH="1">
            <a:off x="1630677" y="3083997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1630677" y="311715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1712894" y="3609000"/>
            <a:ext cx="5627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Gerade Verbindung mit Pfeil 53"/>
          <p:cNvCxnSpPr/>
          <p:nvPr/>
        </p:nvCxnSpPr>
        <p:spPr>
          <a:xfrm flipH="1">
            <a:off x="1630677" y="3704987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H="1">
            <a:off x="1630677" y="3750459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1712894" y="3862589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3 (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Gerade Verbindung mit Pfeil 56"/>
          <p:cNvCxnSpPr/>
          <p:nvPr/>
        </p:nvCxnSpPr>
        <p:spPr>
          <a:xfrm flipH="1">
            <a:off x="1630677" y="400027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1712894" y="3972661"/>
            <a:ext cx="1608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3 (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/>
          <p:cNvCxnSpPr/>
          <p:nvPr/>
        </p:nvCxnSpPr>
        <p:spPr>
          <a:xfrm flipH="1">
            <a:off x="1630677" y="4110345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feld 59"/>
          <p:cNvSpPr txBox="1"/>
          <p:nvPr/>
        </p:nvSpPr>
        <p:spPr>
          <a:xfrm>
            <a:off x="1712894" y="4227691"/>
            <a:ext cx="5579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9/17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Gerade Verbindung mit Pfeil 60"/>
          <p:cNvCxnSpPr/>
          <p:nvPr/>
        </p:nvCxnSpPr>
        <p:spPr>
          <a:xfrm flipH="1">
            <a:off x="1630677" y="4327521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/>
          <p:cNvCxnSpPr/>
          <p:nvPr/>
        </p:nvCxnSpPr>
        <p:spPr>
          <a:xfrm flipH="1">
            <a:off x="1630677" y="4366225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Grafik 6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90" t="27146" r="28783" b="66572"/>
          <a:stretch/>
        </p:blipFill>
        <p:spPr>
          <a:xfrm>
            <a:off x="542680" y="2646501"/>
            <a:ext cx="1080000" cy="1215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feld 63"/>
          <p:cNvSpPr txBox="1"/>
          <p:nvPr/>
        </p:nvSpPr>
        <p:spPr>
          <a:xfrm>
            <a:off x="1712894" y="2567185"/>
            <a:ext cx="1025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1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Gerade Verbindung mit Pfeil 64"/>
          <p:cNvCxnSpPr/>
          <p:nvPr/>
        </p:nvCxnSpPr>
        <p:spPr>
          <a:xfrm flipH="1">
            <a:off x="1630677" y="2689371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/>
          <p:cNvCxnSpPr/>
          <p:nvPr/>
        </p:nvCxnSpPr>
        <p:spPr>
          <a:xfrm flipH="1">
            <a:off x="1630677" y="2722527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7" name="Grafik 6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87" t="32747" r="33386" b="59008"/>
          <a:stretch/>
        </p:blipFill>
        <p:spPr>
          <a:xfrm>
            <a:off x="542680" y="2778064"/>
            <a:ext cx="1080000" cy="1595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Textfeld 67"/>
          <p:cNvSpPr txBox="1"/>
          <p:nvPr/>
        </p:nvSpPr>
        <p:spPr>
          <a:xfrm>
            <a:off x="1552129" y="2111918"/>
            <a:ext cx="538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16" t="40970" r="31012" b="53367"/>
          <a:stretch/>
        </p:blipFill>
        <p:spPr>
          <a:xfrm>
            <a:off x="542680" y="2947399"/>
            <a:ext cx="1080000" cy="109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64" t="30989" r="24209" b="37351"/>
          <a:stretch/>
        </p:blipFill>
        <p:spPr>
          <a:xfrm>
            <a:off x="542680" y="3067108"/>
            <a:ext cx="1080000" cy="6126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Grafik 7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77" t="19921" r="33696" b="74507"/>
          <a:stretch/>
        </p:blipFill>
        <p:spPr>
          <a:xfrm>
            <a:off x="542680" y="3685804"/>
            <a:ext cx="1080000" cy="1078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Grafik 7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27" t="25010" r="35846" b="68182"/>
          <a:stretch/>
        </p:blipFill>
        <p:spPr>
          <a:xfrm>
            <a:off x="541571" y="3804804"/>
            <a:ext cx="1080000" cy="1317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8" t="36574" r="31899" b="57508"/>
          <a:stretch/>
        </p:blipFill>
        <p:spPr>
          <a:xfrm>
            <a:off x="541571" y="3945282"/>
            <a:ext cx="1080000" cy="1146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68" t="37040" r="31805" b="41500"/>
          <a:stretch/>
        </p:blipFill>
        <p:spPr>
          <a:xfrm>
            <a:off x="541571" y="4069641"/>
            <a:ext cx="1080000" cy="4153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Grafik 74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58" t="28371" r="32015" b="65368"/>
          <a:stretch/>
        </p:blipFill>
        <p:spPr>
          <a:xfrm>
            <a:off x="541571" y="4491537"/>
            <a:ext cx="1080000" cy="1211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Textfeld 75"/>
          <p:cNvSpPr txBox="1"/>
          <p:nvPr/>
        </p:nvSpPr>
        <p:spPr>
          <a:xfrm>
            <a:off x="103155" y="1981147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741203" y="1948179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,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30800" y="3095212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130800" y="2994080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130800" y="2599220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7/5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286790" y="2694150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286790" y="2783957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286790" y="2884509"/>
            <a:ext cx="471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69534" y="3635259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16/89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283584" y="3751064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283584" y="3901106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283584" y="4031394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283584" y="4467555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127594" y="4257798"/>
            <a:ext cx="532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9/17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918772" y="60464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,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, 4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Grafik 9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6113" y="146793"/>
            <a:ext cx="1800000" cy="1796329"/>
          </a:xfrm>
          <a:prstGeom prst="rect">
            <a:avLst/>
          </a:prstGeom>
        </p:spPr>
      </p:pic>
      <p:pic>
        <p:nvPicPr>
          <p:cNvPr id="92" name="Grafik 9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718" y="309300"/>
            <a:ext cx="1800000" cy="1626241"/>
          </a:xfrm>
          <a:prstGeom prst="rect">
            <a:avLst/>
          </a:prstGeom>
        </p:spPr>
      </p:pic>
      <p:sp>
        <p:nvSpPr>
          <p:cNvPr id="93" name="Textfeld 92"/>
          <p:cNvSpPr txBox="1"/>
          <p:nvPr/>
        </p:nvSpPr>
        <p:spPr>
          <a:xfrm>
            <a:off x="676306" y="106282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,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Grafik 93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824" y="248885"/>
            <a:ext cx="1800000" cy="1680082"/>
          </a:xfrm>
          <a:prstGeom prst="rect">
            <a:avLst/>
          </a:prstGeom>
        </p:spPr>
      </p:pic>
      <p:sp>
        <p:nvSpPr>
          <p:cNvPr id="95" name="Textfeld 94"/>
          <p:cNvSpPr txBox="1"/>
          <p:nvPr/>
        </p:nvSpPr>
        <p:spPr>
          <a:xfrm>
            <a:off x="2689245" y="106282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,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, 72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235031" y="8914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2301660" y="8914"/>
            <a:ext cx="3591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4493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754566" y="2705136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767054" y="5205365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6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0" y="-9623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-3" y="4995043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22"/>
          <a:stretch/>
        </p:blipFill>
        <p:spPr>
          <a:xfrm>
            <a:off x="391730" y="144384"/>
            <a:ext cx="5055108" cy="2525802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2767054" y="95684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V4-11, 1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30"/>
          <a:stretch/>
        </p:blipFill>
        <p:spPr>
          <a:xfrm>
            <a:off x="391730" y="2781706"/>
            <a:ext cx="5053584" cy="2435250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0" y="2474450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10"/>
          <a:stretch/>
        </p:blipFill>
        <p:spPr>
          <a:xfrm>
            <a:off x="391730" y="5139897"/>
            <a:ext cx="5126736" cy="2454904"/>
          </a:xfrm>
          <a:prstGeom prst="rect">
            <a:avLst/>
          </a:prstGeom>
        </p:spPr>
      </p:pic>
      <p:sp>
        <p:nvSpPr>
          <p:cNvPr id="5" name="Rechteck 4"/>
          <p:cNvSpPr/>
          <p:nvPr/>
        </p:nvSpPr>
        <p:spPr>
          <a:xfrm>
            <a:off x="0" y="7578746"/>
            <a:ext cx="6858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-positive and double positive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on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IPinB, BV6 and DL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-C) MV4-11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 (B)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6 (C)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LIPinB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V6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VAD-fmk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ec-1s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ward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6 h (A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2 h (B,C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IL (A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95L (B,C). Cell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in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-FITC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I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a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maging Flow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egative (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l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-FITC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nex-V-FITC/PI positive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,C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19" t="3072" b="89493"/>
          <a:stretch/>
        </p:blipFill>
        <p:spPr>
          <a:xfrm>
            <a:off x="5203871" y="3740690"/>
            <a:ext cx="1747603" cy="202131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57" t="4547" r="35311" b="88726"/>
          <a:stretch/>
        </p:blipFill>
        <p:spPr>
          <a:xfrm>
            <a:off x="5203871" y="3458726"/>
            <a:ext cx="1482290" cy="182880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7" r="64421" b="89362"/>
          <a:stretch/>
        </p:blipFill>
        <p:spPr>
          <a:xfrm>
            <a:off x="4499459" y="3612731"/>
            <a:ext cx="1798023" cy="178916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447" t="3584" b="89565"/>
          <a:stretch/>
        </p:blipFill>
        <p:spPr>
          <a:xfrm>
            <a:off x="5213496" y="1173719"/>
            <a:ext cx="1797254" cy="192505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19" t="3072" b="89493"/>
          <a:stretch/>
        </p:blipFill>
        <p:spPr>
          <a:xfrm>
            <a:off x="5203871" y="6168648"/>
            <a:ext cx="1747603" cy="202131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57" t="4547" r="35311" b="88726"/>
          <a:stretch/>
        </p:blipFill>
        <p:spPr>
          <a:xfrm>
            <a:off x="5203871" y="5886684"/>
            <a:ext cx="1482290" cy="182880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7" r="64421" b="89362"/>
          <a:stretch/>
        </p:blipFill>
        <p:spPr>
          <a:xfrm>
            <a:off x="4499459" y="6040689"/>
            <a:ext cx="1798023" cy="178916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57" t="4547" r="35311" b="88726"/>
          <a:stretch/>
        </p:blipFill>
        <p:spPr>
          <a:xfrm>
            <a:off x="5205905" y="848481"/>
            <a:ext cx="1482290" cy="18288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7" r="64421" b="89362"/>
          <a:stretch/>
        </p:blipFill>
        <p:spPr>
          <a:xfrm>
            <a:off x="4501493" y="1002486"/>
            <a:ext cx="1798023" cy="178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8723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0558240"/>
              </p:ext>
            </p:extLst>
          </p:nvPr>
        </p:nvGraphicFramePr>
        <p:xfrm>
          <a:off x="578561" y="930586"/>
          <a:ext cx="1798264" cy="596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4783">
                  <a:extLst>
                    <a:ext uri="{9D8B030D-6E8A-4147-A177-3AD203B41FA5}">
                      <a16:colId xmlns:a16="http://schemas.microsoft.com/office/drawing/2014/main" val="92975363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1624820090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3169522250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3003388787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2721011522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2284111872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1421307760"/>
                    </a:ext>
                  </a:extLst>
                </a:gridCol>
                <a:gridCol w="224783">
                  <a:extLst>
                    <a:ext uri="{9D8B030D-6E8A-4147-A177-3AD203B41FA5}">
                      <a16:colId xmlns:a16="http://schemas.microsoft.com/office/drawing/2014/main" val="2383079239"/>
                    </a:ext>
                  </a:extLst>
                </a:gridCol>
              </a:tblGrid>
              <a:tr h="149070"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9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6646183"/>
                  </a:ext>
                </a:extLst>
              </a:tr>
              <a:tr h="149070"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9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0779397"/>
                  </a:ext>
                </a:extLst>
              </a:tr>
              <a:tr h="149070"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9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039788"/>
                  </a:ext>
                </a:extLst>
              </a:tr>
              <a:tr h="149070"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115275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2326672" y="1015253"/>
            <a:ext cx="9172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[4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326672" y="1176039"/>
            <a:ext cx="12827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[4h]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326672" y="880202"/>
            <a:ext cx="12314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 µM FLIPinB</a:t>
            </a:r>
            <a:r>
              <a:rPr lang="el-G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[5h]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326672" y="1337693"/>
            <a:ext cx="13067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[3h]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2504198" y="1660133"/>
            <a:ext cx="13195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63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quitin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36950" y="172356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57341" y="137356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340065" y="404254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504198" y="2171496"/>
            <a:ext cx="12875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63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quitin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36950" y="223628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26683" r="24484" b="57988"/>
          <a:stretch/>
        </p:blipFill>
        <p:spPr>
          <a:xfrm>
            <a:off x="576823" y="1530225"/>
            <a:ext cx="1800000" cy="4784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41" t="26313" r="24378" b="54479"/>
          <a:stretch/>
        </p:blipFill>
        <p:spPr>
          <a:xfrm>
            <a:off x="576823" y="2022168"/>
            <a:ext cx="1800000" cy="6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feld 16"/>
          <p:cNvSpPr txBox="1"/>
          <p:nvPr/>
        </p:nvSpPr>
        <p:spPr>
          <a:xfrm>
            <a:off x="639782" y="656642"/>
            <a:ext cx="7815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IPK1-IP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5"/>
          <p:cNvCxnSpPr/>
          <p:nvPr/>
        </p:nvCxnSpPr>
        <p:spPr>
          <a:xfrm flipH="1" flipV="1">
            <a:off x="581628" y="876175"/>
            <a:ext cx="900000" cy="93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74"/>
          <p:cNvCxnSpPr/>
          <p:nvPr/>
        </p:nvCxnSpPr>
        <p:spPr>
          <a:xfrm flipH="1">
            <a:off x="1726239" y="876981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1806859" y="643121"/>
            <a:ext cx="5628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1" t="31300" r="27408" b="54848"/>
          <a:stretch/>
        </p:blipFill>
        <p:spPr>
          <a:xfrm>
            <a:off x="576823" y="2627928"/>
            <a:ext cx="1800000" cy="4326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feld 21"/>
          <p:cNvSpPr txBox="1"/>
          <p:nvPr/>
        </p:nvSpPr>
        <p:spPr>
          <a:xfrm>
            <a:off x="2504198" y="2732906"/>
            <a:ext cx="11015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K48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quitinatio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36950" y="27893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 Verbindung mit Pfeil 23"/>
          <p:cNvCxnSpPr/>
          <p:nvPr/>
        </p:nvCxnSpPr>
        <p:spPr>
          <a:xfrm flipH="1">
            <a:off x="2395873" y="1771188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2395873" y="284751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2395873" y="229506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710" t="40367" r="21044" b="53639"/>
          <a:stretch/>
        </p:blipFill>
        <p:spPr>
          <a:xfrm>
            <a:off x="1659088" y="3368014"/>
            <a:ext cx="720000" cy="1866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4" t="40701" r="23203" b="54227"/>
          <a:stretch/>
        </p:blipFill>
        <p:spPr>
          <a:xfrm>
            <a:off x="576823" y="3211453"/>
            <a:ext cx="1800000" cy="1582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48" t="41547" r="23519" b="54015"/>
          <a:stretch/>
        </p:blipFill>
        <p:spPr>
          <a:xfrm>
            <a:off x="576823" y="3070631"/>
            <a:ext cx="1800000" cy="1384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feld 29"/>
          <p:cNvSpPr txBox="1"/>
          <p:nvPr/>
        </p:nvSpPr>
        <p:spPr>
          <a:xfrm>
            <a:off x="2504198" y="3020226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Gerade Verbindung mit Pfeil 30"/>
          <p:cNvCxnSpPr/>
          <p:nvPr/>
        </p:nvCxnSpPr>
        <p:spPr>
          <a:xfrm flipH="1">
            <a:off x="2395873" y="3134833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2504198" y="3193754"/>
            <a:ext cx="7040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2395873" y="3308361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2501933" y="3323851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Gerade Verbindung mit Pfeil 34"/>
          <p:cNvCxnSpPr/>
          <p:nvPr/>
        </p:nvCxnSpPr>
        <p:spPr>
          <a:xfrm flipH="1">
            <a:off x="2393608" y="3438458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/>
          <p:cNvSpPr txBox="1"/>
          <p:nvPr/>
        </p:nvSpPr>
        <p:spPr>
          <a:xfrm>
            <a:off x="336950" y="30475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36950" y="317620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379790" y="334677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-23381" y="4243492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IPK1 </a:t>
            </a:r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biquitinylation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pon DL/BV6/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IPin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29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LIPinB</a:t>
            </a:r>
            <a:r>
              <a:rPr lang="el-GR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h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V6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VAD-fmk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ward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 h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95L. pRIPK1 was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ecipit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ti-pRIPK1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P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tal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sate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ut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IP: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recipitation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rt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sour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e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ng</a:t>
            </a:r>
            <a:r>
              <a:rPr lang="de-DE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osur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80621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-7095" y="2728485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353962" y="2728485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1981" y="2896062"/>
            <a:ext cx="3240000" cy="2293313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1232627" y="2792517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7, 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7020" y="2926588"/>
            <a:ext cx="3240000" cy="2278125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4790222" y="2792517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7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-7095" y="27038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374509" y="27038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188035" y="9959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, 24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3091"/>
            <a:ext cx="2880000" cy="2654041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591" y="173090"/>
            <a:ext cx="2880000" cy="26880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4749566" y="-2086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, 4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604743" y="5299900"/>
            <a:ext cx="1360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048" y="5332472"/>
            <a:ext cx="2880000" cy="2357788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>
            <a:off x="3036349" y="5155064"/>
            <a:ext cx="1818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, 8 h</a:t>
            </a:r>
            <a:endParaRPr lang="en-AU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-54491" y="7719845"/>
            <a:ext cx="691249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ss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on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IPinB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BV6/CD95L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-E) Primary T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 (A,B)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7 (C,D),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 (E)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IPinBγ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,B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µM FLIPinB (C,D,E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h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 µM (A,B,E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 µM (C,D) BV6, 50 µM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VA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10 µM Nec-1s. Cell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imulat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0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95L (A-E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00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95L (A,B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6 h (C,E), 24 h (A,D)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8 h (B).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iter-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®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uminesc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ility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say. The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>
              <a:spcAft>
                <a:spcPts val="0"/>
              </a:spcAft>
            </a:pPr>
            <a:r>
              <a:rPr lang="de-DE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887588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03</Words>
  <Application>Microsoft Office PowerPoint</Application>
  <PresentationFormat>Bildschirmpräsentation (4:3)</PresentationFormat>
  <Paragraphs>153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llert, Laura</dc:creator>
  <cp:lastModifiedBy>Lavrik, Inna</cp:lastModifiedBy>
  <cp:revision>227</cp:revision>
  <cp:lastPrinted>2021-09-09T11:54:35Z</cp:lastPrinted>
  <dcterms:created xsi:type="dcterms:W3CDTF">2020-07-10T11:27:08Z</dcterms:created>
  <dcterms:modified xsi:type="dcterms:W3CDTF">2024-09-08T17:07:20Z</dcterms:modified>
</cp:coreProperties>
</file>